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33339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1066680" y="1523880"/>
          <a:ext cx="6508800" cy="4343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66680" y="1523880"/>
                    <a:ext cx="6508800" cy="434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0" name=""/>
          <p:cNvSpPr/>
          <p:nvPr/>
        </p:nvSpPr>
        <p:spPr>
          <a:xfrm>
            <a:off x="2514600" y="5759280"/>
            <a:ext cx="4191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ultiplier for Relative Infectiousness of Symptomatic Infectiv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"/>
          <p:cNvSpPr/>
          <p:nvPr/>
        </p:nvSpPr>
        <p:spPr>
          <a:xfrm>
            <a:off x="7543800" y="2362320"/>
            <a:ext cx="1295280" cy="1894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accine Cover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0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50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70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620120" y="3137040"/>
            <a:ext cx="304560" cy="228600"/>
          </a:xfrm>
          <a:prstGeom prst="rec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620120" y="3543480"/>
            <a:ext cx="304560" cy="228600"/>
          </a:xfrm>
          <a:prstGeom prst="rect">
            <a:avLst/>
          </a:prstGeom>
          <a:solidFill>
            <a:srgbClr val="008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620120" y="3936960"/>
            <a:ext cx="304560" cy="22860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-877680" y="3244680"/>
            <a:ext cx="3810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verage Overall Effectiveness (%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676520" y="1386000"/>
            <a:ext cx="24382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VE</a:t>
            </a:r>
            <a:r>
              <a:rPr b="0" lang="en-US" sz="1800" spc="-1" strike="noStrike" baseline="-25000">
                <a:solidFill>
                  <a:srgbClr val="333399"/>
                </a:solidFill>
                <a:latin typeface="Arial"/>
              </a:rPr>
              <a:t>I</a:t>
            </a: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=0.5</a:t>
            </a: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	</a:t>
            </a: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 VE</a:t>
            </a:r>
            <a:r>
              <a:rPr b="0" lang="en-US" sz="1800" spc="-1" strike="noStrike" baseline="-25000">
                <a:solidFill>
                  <a:srgbClr val="333399"/>
                </a:solidFill>
                <a:latin typeface="Arial"/>
              </a:rPr>
              <a:t>S</a:t>
            </a: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=0.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2T23:43:03Z</dcterms:created>
  <dc:creator>nshenvi</dc:creator>
  <dc:description/>
  <dc:language>en-US</dc:language>
  <cp:lastModifiedBy>longini</cp:lastModifiedBy>
  <dcterms:modified xsi:type="dcterms:W3CDTF">2007-09-25T23:47:27Z</dcterms:modified>
  <cp:revision>298</cp:revision>
  <dc:subject/>
  <dc:title>Slide 1</dc:title>
</cp:coreProperties>
</file>